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082"/>
    <p:restoredTop sz="70476"/>
  </p:normalViewPr>
  <p:slideViewPr>
    <p:cSldViewPr snapToGrid="0">
      <p:cViewPr varScale="1">
        <p:scale>
          <a:sx n="52" d="100"/>
          <a:sy n="52" d="100"/>
        </p:scale>
        <p:origin x="100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3495EE-7146-B54C-B961-B70B2749EE57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7875B-2D97-1345-B9DF-2FF4CBAE7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378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S6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TJ protein expression by western blot.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O-1 and occludin expression shown along side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actin loading control. Graph represents fold-change quantification on the Y-axis of ZO-1 and occludin expression against the expression on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-derived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BMECs alone normalized to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actin control. Values are presented as mean (SEM) of three independent differentiations.</a:t>
            </a:r>
            <a:endParaRPr lang="en-US" sz="2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13CCC-C203-394F-8D31-2DD52CC57F8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467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52E667B-26BE-3160-0F57-F66CC2667C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04AAA9A-81F7-A755-009C-A5981EF1AF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D663E89-E986-EF80-517C-6BBEC3126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E52A7F7-3322-28E9-D8B1-DC61ACC2B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F80D64A-A644-B621-849C-E0B1F937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15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984FD9-36BC-6DBB-888C-04C9CFFD8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483D557-414A-93BF-4656-7713C4C5BD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24A6DA7-AD27-819C-FFCC-59EB2A79A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6B82AC5-8AF2-C00C-CE6D-AC97330D1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4276C63-97D4-7298-5D6F-036617B1F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522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EE43AE0-3980-3EB0-61AC-9C6F6E98F9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36EF673-C33A-B243-F113-A936C7072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3F764A9-177E-F87C-9594-4EE062710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CB5775-FA4A-DBB7-7CEF-6AC0312D0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A096DF-F32B-86A2-EC1D-B79671B5D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548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901F875-216E-BDB3-D891-BD6DF98D4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126FF8B-50E4-1428-D316-9A1B92A4A1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01BA963-EC7C-A6A9-2DAA-5FBD10CE1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C24E6EA-6BF8-9DC4-F725-F2A46B4AE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E7E0CB4-41EA-9445-DE2D-E2E1B9ABD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495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F7C2924-1F82-A86E-28F3-F5FF96CFA0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E1C6126-6F42-E1AA-B344-B44D953A8E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79B59E-8EAF-1CFE-2115-FC54C6686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0F6676A-3F35-F2BF-2FC3-E70FA6A31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4AE0F11-1BDA-A2A5-04DA-716DEDA84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87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7F9249A-9014-B866-25F7-43326032B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39677F4-260F-CD32-141C-2B18B1F55A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608DF41-BA82-A704-B08F-A98287EBCD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53875C6-420C-5A02-3D5F-FCA54DDDB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17BF338-856E-FECD-89AB-8C90BB3BA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87275A6-6276-002E-BC6A-8607DD6B1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13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CFC062-85B6-6E5A-59C6-5E0BB13B1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4605B62-2ABD-9A78-0FDD-17AFF44DC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FE64935-765B-28FE-77A9-04C1019437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19575BE-ED2F-0D23-BA6F-05B9C2F2D8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B29ED4D4-0F9C-4966-731A-E23EBE59AE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066A971-5D22-A52A-DC7B-4963B26EC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7515A07-A62B-408D-DC5D-A6C201768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43574AC-7EDC-6552-17B0-325D3908E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971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53377A3-8CC2-5946-421D-EB30BFC36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2D0217C-F337-58C5-DE89-71D4EFE60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19F2B8F-9ECC-D526-882C-C1A0E6B05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8972BAE-CF87-8095-825B-BB62DD344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444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12D4D337-DE5F-3746-EE1E-3244F48B9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F39F5F7-57D2-072B-7BD6-6F4BD5F8C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A8B9BAB-FFAB-3D24-7581-656FE3643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283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C9B3892-770B-CB15-E881-429961B322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B565FB1-0BB2-4D6A-8A3B-850667F5B3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9439ECE-296E-1106-7556-35E1177EDF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76C0A6A-4A1E-035E-4C02-FBD354105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FC5EFAB-E997-F80D-3E7C-4AB2CB3AF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9198714-D3CD-610E-86D9-3774D0680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742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A7B631-6BB1-A3F5-A653-B08FB67A3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2A697F90-3022-F3D0-51DC-A47B3BB641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F63B982-67C0-C9C1-C850-3CEF55082A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89D644A-61C2-E74D-A32A-D6435C2B0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469AAAE-50BA-D2F4-103B-4C31F321D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DAF0036-5F32-ACA5-F55A-0D1F862B3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303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856AE168-BAEA-FABF-47B6-9B085A0AC7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F5A7A42-9990-5C5E-4177-164DEB280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7B36CD5-7791-EB87-0E6F-F8BCB58EBF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AF36FF-5EE0-5344-9F04-38F6C15D8272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7474B64-78F8-FF22-18E9-8D077DEA3F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E171A3E-569E-FACF-44D6-D2FB599F5D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93222F-68FA-7048-B953-A234351E0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02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5D3ADBD-908A-A1DC-EC42-BE9AF2261C01}"/>
              </a:ext>
            </a:extLst>
          </p:cNvPr>
          <p:cNvSpPr txBox="1"/>
          <p:nvPr/>
        </p:nvSpPr>
        <p:spPr>
          <a:xfrm>
            <a:off x="2302099" y="5153914"/>
            <a:ext cx="71594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kern="50" spc="-15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S6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TJ protein expression by western blot.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ZO-1 and </a:t>
            </a:r>
            <a:r>
              <a:rPr lang="en-US" sz="10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ccludin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expression shown along side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actin loading control. Graph represents fold-change quantification on the Y-axis of ZO-1 and occludin expression against the expression on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-derived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BMECs alone normalized to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actin control. Values are presented as mean (SEM) of three independent differentiations.</a:t>
            </a:r>
            <a:endParaRPr lang="en-US" sz="1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64EF5D3-6C8A-3633-8426-D3C22417EF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2099" y="1708889"/>
            <a:ext cx="7159401" cy="3179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652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Props1.xml><?xml version="1.0" encoding="utf-8"?>
<ds:datastoreItem xmlns:ds="http://schemas.openxmlformats.org/officeDocument/2006/customXml" ds:itemID="{B073D18C-EA0B-4965-B6FE-00AD4F9EA4A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BF1B920-308D-4634-9257-EE74302BEC9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463C621-6C6E-49CF-B6B2-AF0E8B47F178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3</cp:revision>
  <dcterms:created xsi:type="dcterms:W3CDTF">2024-04-11T17:10:43Z</dcterms:created>
  <dcterms:modified xsi:type="dcterms:W3CDTF">2024-04-20T11:5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</Properties>
</file>